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90" d="100"/>
          <a:sy n="90" d="100"/>
        </p:scale>
        <p:origin x="57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281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30876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956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0796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1052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8603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69842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134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1712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27454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80407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B291AA-8D8F-4A66-ABA6-96F0F9FC0493}" type="datetimeFigureOut">
              <a:rPr lang="en-US" smtClean="0"/>
              <a:t>11/7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32F725-471C-4518-8CEE-CDF1025E8C6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199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99" t="34375" r="60175" b="32292"/>
          <a:stretch>
            <a:fillRect/>
          </a:stretch>
        </p:blipFill>
        <p:spPr bwMode="auto">
          <a:xfrm>
            <a:off x="690381" y="510750"/>
            <a:ext cx="4523920" cy="31895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641" t="31250" r="57246" b="36458"/>
          <a:stretch>
            <a:fillRect/>
          </a:stretch>
        </p:blipFill>
        <p:spPr bwMode="auto">
          <a:xfrm>
            <a:off x="5914489" y="551442"/>
            <a:ext cx="4811612" cy="31082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41" t="32292" r="51392" b="35416"/>
          <a:stretch>
            <a:fillRect/>
          </a:stretch>
        </p:blipFill>
        <p:spPr bwMode="auto">
          <a:xfrm>
            <a:off x="621500" y="3514127"/>
            <a:ext cx="4735124" cy="31954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58239" y="47297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77377" y="3659653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557652" y="472978"/>
            <a:ext cx="3568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2" name="TextBox 1"/>
          <p:cNvSpPr txBox="1"/>
          <p:nvPr/>
        </p:nvSpPr>
        <p:spPr>
          <a:xfrm>
            <a:off x="5240944" y="4764077"/>
            <a:ext cx="6798656" cy="9541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Bacterial community alpha diversity. 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cterial diversity represented by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non index (A), Chao 1 (B) or Phylogenetic diversity tree (C) at genus level for samples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each dietary treatment group. Each box plot represents the distribution of the samples </a:t>
            </a:r>
          </a:p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rom pigs fed different diets. </a:t>
            </a:r>
          </a:p>
        </p:txBody>
      </p:sp>
    </p:spTree>
    <p:extLst>
      <p:ext uri="{BB962C8B-B14F-4D97-AF65-F5344CB8AC3E}">
        <p14:creationId xmlns:p14="http://schemas.microsoft.com/office/powerpoint/2010/main" val="29121230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58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olano-Aguilar, Gloria</dc:creator>
  <cp:lastModifiedBy>Solano-Aguilar, Gloria</cp:lastModifiedBy>
  <cp:revision>4</cp:revision>
  <dcterms:created xsi:type="dcterms:W3CDTF">2018-09-19T21:56:30Z</dcterms:created>
  <dcterms:modified xsi:type="dcterms:W3CDTF">2018-11-07T23:13:32Z</dcterms:modified>
</cp:coreProperties>
</file>